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CDDCC-A4B5-409B-89F4-76C5DAC214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6AB6C-7ED0-4C44-A129-2AA9483F91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FC725-0A3B-4E75-ACB5-88B17D8F6C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18559-4D80-4CD7-AD16-6A1D56E04B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9E01B-FE42-4315-8BB8-2206C6624A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48E59-9EDB-496C-B8C8-185F0BC3C4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ACE6F-050A-4F4B-8AC2-DA34CF1941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2890E-534E-4C0F-B4B8-91FCEC2698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DD0CC-15C9-4752-9A61-1F91CCE0A1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6F930-2C5C-4742-8C15-517213DB3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BC89D-34AD-4DE9-85D8-649859A73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14964-2CE5-489C-8588-F24C66CA86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74ACEC-91DA-4D6C-BB6E-13E8971424EE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733920" y="843120"/>
            <a:ext cx="2361960" cy="23572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066680" y="838080"/>
            <a:ext cx="2362320" cy="23623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4038480" y="1066680"/>
            <a:ext cx="38124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53560" y="3124080"/>
            <a:ext cx="11073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Expect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453920" y="3124080"/>
            <a:ext cx="11073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Expect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537120" y="1902600"/>
            <a:ext cx="11224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Observ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3218400" y="1919880"/>
            <a:ext cx="11224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Observ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821960" y="746280"/>
            <a:ext cx="1072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onatal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26280" y="746280"/>
            <a:ext cx="883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fant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3"/>
          <a:stretch/>
        </p:blipFill>
        <p:spPr>
          <a:xfrm>
            <a:off x="1066680" y="3809880"/>
            <a:ext cx="2514600" cy="23958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1829880" y="6095880"/>
            <a:ext cx="11073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Expect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613080" y="4891680"/>
            <a:ext cx="11224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800" spc="-1" strike="noStrike">
                <a:solidFill>
                  <a:srgbClr val="000000"/>
                </a:solidFill>
                <a:latin typeface="Arial"/>
              </a:rPr>
              <a:t>Observed d(i) 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79680" y="3733920"/>
            <a:ext cx="16210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onatal vs. Infant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90680" y="722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35320" y="3809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447920" y="4038480"/>
            <a:ext cx="380880" cy="609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371600" y="1066680"/>
            <a:ext cx="380880" cy="609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85800" y="6629400"/>
            <a:ext cx="5562720" cy="247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4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Online Supplementary Figure 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AM quantile-quantile plots for CRM197-induced gene profi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4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Quantile-quantile (qq) plots 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</a:rPr>
              <a:t>generated during SAM analysis for A) gene expressions in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RM197-stimulated compared to unstimulated PBMC in the neonatal and infant group (5 x 5 PBMC per group) (in green are the genes that are significantly differentially expressed in response to CRM197), and B) relative CRM197-induced gene expression in the neonatal versus the infant vaccination group,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</a:rPr>
              <a:t> indicating that the observed test statistics do not deviate from the null hypothesis (Ho = gene expressions are similar between the two vaccination groups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6T01:09:37Z</dcterms:created>
  <dc:creator>anitav</dc:creator>
  <dc:description/>
  <dc:language>en-US</dc:language>
  <cp:lastModifiedBy>van den Biggelaar</cp:lastModifiedBy>
  <dcterms:modified xsi:type="dcterms:W3CDTF">2011-02-21T14:27:08Z</dcterms:modified>
  <cp:revision>4</cp:revision>
  <dc:subject/>
  <dc:title>Slide 1</dc:title>
</cp:coreProperties>
</file>